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6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1.jpeg" ContentType="image/jpeg"/>
  <Override PartName="/ppt/media/image18.jpeg" ContentType="image/jpeg"/>
  <Override PartName="/ppt/media/image17.jpeg" ContentType="image/jpeg"/>
  <Override PartName="/ppt/media/image14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7737138" cy="17830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fld id="{94B832B6-0288-4D9A-9A17-F8FDC8B938B9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724040" y="685440"/>
            <a:ext cx="340992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638"/>
              </a:spcBef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fld id="{55912238-F568-4E89-B9B8-DDF572479B0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PlaceHolder 1"/>
          <p:cNvSpPr>
            <a:spLocks noGrp="1"/>
          </p:cNvSpPr>
          <p:nvPr>
            <p:ph type="sldImg"/>
          </p:nvPr>
        </p:nvSpPr>
        <p:spPr>
          <a:xfrm>
            <a:off x="1724040" y="685800"/>
            <a:ext cx="3409920" cy="3429000"/>
          </a:xfrm>
          <a:prstGeom prst="rect">
            <a:avLst/>
          </a:prstGeom>
          <a:ln w="0">
            <a:noFill/>
          </a:ln>
        </p:spPr>
      </p:sp>
      <p:sp>
        <p:nvSpPr>
          <p:cNvPr id="35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638"/>
              </a:spcBef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fld id="{D5973335-D35C-43FC-818D-737022DAF2B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17E221-5AF4-4ADC-A7A6-95AF01D040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87400" y="4160520"/>
            <a:ext cx="159638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87400" y="10306440"/>
            <a:ext cx="159638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0C0F2-53C4-4721-BB7E-D2C705D597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87400" y="416052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9067320" y="416052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87400" y="1030644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9067320" y="1030644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2CE06-8EA6-4082-9F9E-4017E183F5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87400" y="4160520"/>
            <a:ext cx="514008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6284880" y="4160520"/>
            <a:ext cx="514008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1682360" y="4160520"/>
            <a:ext cx="514008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87400" y="10306440"/>
            <a:ext cx="514008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6284880" y="10306440"/>
            <a:ext cx="514008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1682360" y="10306440"/>
            <a:ext cx="514008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2E886-F269-4056-AA13-819820A9F5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87400" y="4160520"/>
            <a:ext cx="15963840" cy="1176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74"/>
              </a:spcBef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B3759-BD5D-4185-8285-A67BDD0DAC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87400" y="4160520"/>
            <a:ext cx="15963840" cy="117666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BCD4E-41A1-4CCF-988A-5739F26020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87400" y="4160520"/>
            <a:ext cx="7790040" cy="117666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9067320" y="4160520"/>
            <a:ext cx="7790040" cy="117666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85592-C425-4516-BC3B-ECEFC80710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FE28C7-E535-4A1C-9194-8E020020B7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87400" y="713880"/>
            <a:ext cx="15963840" cy="1377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74"/>
              </a:spcBef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56E7B-679C-4F70-851B-3CEC31DAE5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87400" y="416052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9067320" y="4160520"/>
            <a:ext cx="7790040" cy="117666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87400" y="1030644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02A614-6E9A-4FC4-A995-8098B3649B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87400" y="4160520"/>
            <a:ext cx="7790040" cy="117666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9067320" y="416052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9067320" y="1030644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9B3EF-5128-4E6F-8442-B3E98E499D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87400" y="416052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9067320" y="4160520"/>
            <a:ext cx="77900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87400" y="10306440"/>
            <a:ext cx="15963840" cy="56124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8077B8-2740-476A-88F8-2D88E92C60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87400" y="713880"/>
            <a:ext cx="15963840" cy="29718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 algn="ctr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5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87400" y="4160520"/>
            <a:ext cx="15963840" cy="1176660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t">
            <a:normAutofit/>
          </a:bodyPr>
          <a:p>
            <a:pPr marL="463680" indent="-463680">
              <a:spcBef>
                <a:spcPts val="1074"/>
              </a:spcBef>
              <a:buClr>
                <a:srgbClr val="000000"/>
              </a:buClr>
              <a:buFont typeface="Arial"/>
              <a:buChar char="•"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1" marL="1006560" indent="-387360">
              <a:spcBef>
                <a:spcPts val="1074"/>
              </a:spcBef>
              <a:buClr>
                <a:srgbClr val="000000"/>
              </a:buClr>
              <a:buFont typeface="Arial"/>
              <a:buChar char="–"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2" marL="1549440" indent="-309600">
              <a:spcBef>
                <a:spcPts val="1074"/>
              </a:spcBef>
              <a:buClr>
                <a:srgbClr val="000000"/>
              </a:buClr>
              <a:buFont typeface="Arial"/>
              <a:buChar char="•"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3" marL="2170080" indent="-309600">
              <a:spcBef>
                <a:spcPts val="1074"/>
              </a:spcBef>
              <a:buClr>
                <a:srgbClr val="000000"/>
              </a:buClr>
              <a:buFont typeface="Arial"/>
              <a:buChar char="–"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4" marL="2789280" indent="-309600">
              <a:spcBef>
                <a:spcPts val="1074"/>
              </a:spcBef>
              <a:buClr>
                <a:srgbClr val="000000"/>
              </a:buClr>
              <a:buFont typeface="Arial"/>
              <a:buChar char="»"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5" marL="2789280" indent="-309600">
              <a:spcBef>
                <a:spcPts val="1074"/>
              </a:spcBef>
              <a:buClr>
                <a:srgbClr val="000000"/>
              </a:buClr>
              <a:buFont typeface="Arial"/>
              <a:buChar char="»"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  <a:p>
            <a:pPr lvl="6" marL="2789280" indent="-309600">
              <a:spcBef>
                <a:spcPts val="1074"/>
              </a:spcBef>
              <a:buClr>
                <a:srgbClr val="000000"/>
              </a:buClr>
              <a:buFont typeface="Arial"/>
              <a:buChar char="»"/>
              <a:tabLst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87400" y="16525440"/>
            <a:ext cx="4138560" cy="94932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  <a:defRPr b="0" lang="en-US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fld id="{FAAD0AC5-F794-4652-91EC-6BB9AE1F12A8}" type="datetime">
              <a:rPr b="0" lang="en-US" sz="17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6060960" y="16525440"/>
            <a:ext cx="5616720" cy="94932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p>
            <a:pPr indent="0"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2712680" y="16525440"/>
            <a:ext cx="4138560" cy="949320"/>
          </a:xfrm>
          <a:prstGeom prst="rect">
            <a:avLst/>
          </a:prstGeom>
          <a:noFill/>
          <a:ln w="0">
            <a:noFill/>
          </a:ln>
        </p:spPr>
        <p:txBody>
          <a:bodyPr lIns="124200" rIns="124200" tIns="61920" bIns="619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  <a:defRPr b="0" lang="en-US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fld id="{1937C861-6BF4-4851-8B1D-69D3C74BFB40}" type="slidenum">
              <a:rPr b="0" lang="en-US" sz="1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4.jpeg"/><Relationship Id="rId11" Type="http://schemas.openxmlformats.org/officeDocument/2006/relationships/image" Target="../media/image10.jpeg"/><Relationship Id="rId12" Type="http://schemas.openxmlformats.org/officeDocument/2006/relationships/image" Target="../media/image11.jpeg"/><Relationship Id="rId13" Type="http://schemas.openxmlformats.org/officeDocument/2006/relationships/image" Target="../media/image12.jpeg"/><Relationship Id="rId14" Type="http://schemas.openxmlformats.org/officeDocument/2006/relationships/image" Target="../media/image13.jpeg"/><Relationship Id="rId15" Type="http://schemas.openxmlformats.org/officeDocument/2006/relationships/image" Target="../media/image14.jpeg"/><Relationship Id="rId16" Type="http://schemas.openxmlformats.org/officeDocument/2006/relationships/image" Target="../media/image15.jpeg"/><Relationship Id="rId17" Type="http://schemas.openxmlformats.org/officeDocument/2006/relationships/image" Target="../media/image16.jpeg"/><Relationship Id="rId18" Type="http://schemas.openxmlformats.org/officeDocument/2006/relationships/image" Target="../media/image17.jpeg"/><Relationship Id="rId19" Type="http://schemas.openxmlformats.org/officeDocument/2006/relationships/image" Target="../media/image18.jpeg"/><Relationship Id="rId20" Type="http://schemas.openxmlformats.org/officeDocument/2006/relationships/image" Target="../media/image19.jpeg"/><Relationship Id="rId21" Type="http://schemas.openxmlformats.org/officeDocument/2006/relationships/image" Target="../media/image20.jpeg"/><Relationship Id="rId22" Type="http://schemas.openxmlformats.org/officeDocument/2006/relationships/image" Target="../media/image21.jpeg"/><Relationship Id="rId23" Type="http://schemas.openxmlformats.org/officeDocument/2006/relationships/image" Target="../media/image17.jpeg"/><Relationship Id="rId24" Type="http://schemas.openxmlformats.org/officeDocument/2006/relationships/slideLayout" Target="../slideLayouts/slideLayout1.xml"/><Relationship Id="rId2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Straight Connector 1293"/>
          <p:cNvSpPr/>
          <p:nvPr/>
        </p:nvSpPr>
        <p:spPr>
          <a:xfrm>
            <a:off x="7783560" y="610380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1294"/>
          <p:cNvSpPr/>
          <p:nvPr/>
        </p:nvSpPr>
        <p:spPr>
          <a:xfrm>
            <a:off x="7783560" y="654696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1295"/>
          <p:cNvSpPr/>
          <p:nvPr/>
        </p:nvSpPr>
        <p:spPr>
          <a:xfrm>
            <a:off x="7783560" y="700092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1296"/>
          <p:cNvSpPr/>
          <p:nvPr/>
        </p:nvSpPr>
        <p:spPr>
          <a:xfrm>
            <a:off x="7783560" y="745812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297"/>
          <p:cNvSpPr/>
          <p:nvPr/>
        </p:nvSpPr>
        <p:spPr>
          <a:xfrm>
            <a:off x="7783560" y="424800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1298"/>
          <p:cNvSpPr/>
          <p:nvPr/>
        </p:nvSpPr>
        <p:spPr>
          <a:xfrm>
            <a:off x="7783560" y="469116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1299"/>
          <p:cNvSpPr/>
          <p:nvPr/>
        </p:nvSpPr>
        <p:spPr>
          <a:xfrm>
            <a:off x="7783560" y="514512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1300"/>
          <p:cNvSpPr/>
          <p:nvPr/>
        </p:nvSpPr>
        <p:spPr>
          <a:xfrm>
            <a:off x="7783560" y="560232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1301"/>
          <p:cNvSpPr/>
          <p:nvPr/>
        </p:nvSpPr>
        <p:spPr>
          <a:xfrm>
            <a:off x="7783560" y="379404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55"/>
          <p:cNvSpPr/>
          <p:nvPr/>
        </p:nvSpPr>
        <p:spPr>
          <a:xfrm>
            <a:off x="7300800" y="72961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55"/>
          <p:cNvSpPr/>
          <p:nvPr/>
        </p:nvSpPr>
        <p:spPr>
          <a:xfrm>
            <a:off x="7300800" y="68454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55"/>
          <p:cNvSpPr/>
          <p:nvPr/>
        </p:nvSpPr>
        <p:spPr>
          <a:xfrm>
            <a:off x="7300800" y="63943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55"/>
          <p:cNvSpPr/>
          <p:nvPr/>
        </p:nvSpPr>
        <p:spPr>
          <a:xfrm>
            <a:off x="7300800" y="59436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55"/>
          <p:cNvSpPr/>
          <p:nvPr/>
        </p:nvSpPr>
        <p:spPr>
          <a:xfrm>
            <a:off x="7429680" y="544032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55"/>
          <p:cNvSpPr/>
          <p:nvPr/>
        </p:nvSpPr>
        <p:spPr>
          <a:xfrm>
            <a:off x="7300800" y="49896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55"/>
          <p:cNvSpPr/>
          <p:nvPr/>
        </p:nvSpPr>
        <p:spPr>
          <a:xfrm>
            <a:off x="7300800" y="45385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55"/>
          <p:cNvSpPr/>
          <p:nvPr/>
        </p:nvSpPr>
        <p:spPr>
          <a:xfrm>
            <a:off x="7300800" y="40878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3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55"/>
          <p:cNvSpPr/>
          <p:nvPr/>
        </p:nvSpPr>
        <p:spPr>
          <a:xfrm>
            <a:off x="7300800" y="363384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4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1311"/>
          <p:cNvSpPr/>
          <p:nvPr/>
        </p:nvSpPr>
        <p:spPr>
          <a:xfrm>
            <a:off x="7783560" y="291636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1312"/>
          <p:cNvSpPr/>
          <p:nvPr/>
        </p:nvSpPr>
        <p:spPr>
          <a:xfrm>
            <a:off x="7783560" y="337356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55"/>
          <p:cNvSpPr/>
          <p:nvPr/>
        </p:nvSpPr>
        <p:spPr>
          <a:xfrm>
            <a:off x="7300800" y="321156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55"/>
          <p:cNvSpPr/>
          <p:nvPr/>
        </p:nvSpPr>
        <p:spPr>
          <a:xfrm>
            <a:off x="7300800" y="276084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1315"/>
          <p:cNvSpPr/>
          <p:nvPr/>
        </p:nvSpPr>
        <p:spPr>
          <a:xfrm>
            <a:off x="7783560" y="111744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1316"/>
          <p:cNvSpPr/>
          <p:nvPr/>
        </p:nvSpPr>
        <p:spPr>
          <a:xfrm>
            <a:off x="7783560" y="156060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1317"/>
          <p:cNvSpPr/>
          <p:nvPr/>
        </p:nvSpPr>
        <p:spPr>
          <a:xfrm>
            <a:off x="7783560" y="201132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1318"/>
          <p:cNvSpPr/>
          <p:nvPr/>
        </p:nvSpPr>
        <p:spPr>
          <a:xfrm>
            <a:off x="7783560" y="246852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55"/>
          <p:cNvSpPr/>
          <p:nvPr/>
        </p:nvSpPr>
        <p:spPr>
          <a:xfrm>
            <a:off x="7300800" y="23065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55"/>
          <p:cNvSpPr/>
          <p:nvPr/>
        </p:nvSpPr>
        <p:spPr>
          <a:xfrm>
            <a:off x="7300800" y="18558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55"/>
          <p:cNvSpPr/>
          <p:nvPr/>
        </p:nvSpPr>
        <p:spPr>
          <a:xfrm>
            <a:off x="7300800" y="140508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55"/>
          <p:cNvSpPr/>
          <p:nvPr/>
        </p:nvSpPr>
        <p:spPr>
          <a:xfrm>
            <a:off x="7300800" y="9540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1323"/>
          <p:cNvSpPr/>
          <p:nvPr/>
        </p:nvSpPr>
        <p:spPr>
          <a:xfrm>
            <a:off x="7783560" y="66204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55"/>
          <p:cNvSpPr/>
          <p:nvPr/>
        </p:nvSpPr>
        <p:spPr>
          <a:xfrm>
            <a:off x="7300800" y="5112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55"/>
          <p:cNvSpPr/>
          <p:nvPr/>
        </p:nvSpPr>
        <p:spPr>
          <a:xfrm>
            <a:off x="8129520" y="765324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55"/>
          <p:cNvSpPr/>
          <p:nvPr/>
        </p:nvSpPr>
        <p:spPr>
          <a:xfrm>
            <a:off x="840276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55"/>
          <p:cNvSpPr/>
          <p:nvPr/>
        </p:nvSpPr>
        <p:spPr>
          <a:xfrm>
            <a:off x="874404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55"/>
          <p:cNvSpPr/>
          <p:nvPr/>
        </p:nvSpPr>
        <p:spPr>
          <a:xfrm>
            <a:off x="907848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テキスト ボックス 55"/>
          <p:cNvSpPr/>
          <p:nvPr/>
        </p:nvSpPr>
        <p:spPr>
          <a:xfrm>
            <a:off x="941652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テキスト ボックス 55"/>
          <p:cNvSpPr/>
          <p:nvPr/>
        </p:nvSpPr>
        <p:spPr>
          <a:xfrm>
            <a:off x="975384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55"/>
          <p:cNvSpPr/>
          <p:nvPr/>
        </p:nvSpPr>
        <p:spPr>
          <a:xfrm>
            <a:off x="1008864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55"/>
          <p:cNvSpPr/>
          <p:nvPr/>
        </p:nvSpPr>
        <p:spPr>
          <a:xfrm>
            <a:off x="1042668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1333"/>
          <p:cNvSpPr/>
          <p:nvPr/>
        </p:nvSpPr>
        <p:spPr>
          <a:xfrm flipV="1">
            <a:off x="1021716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Straight Connector 1334"/>
          <p:cNvSpPr/>
          <p:nvPr/>
        </p:nvSpPr>
        <p:spPr>
          <a:xfrm flipV="1">
            <a:off x="819468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Straight Connector 1335"/>
          <p:cNvSpPr/>
          <p:nvPr/>
        </p:nvSpPr>
        <p:spPr>
          <a:xfrm flipV="1">
            <a:off x="853128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1336"/>
          <p:cNvSpPr/>
          <p:nvPr/>
        </p:nvSpPr>
        <p:spPr>
          <a:xfrm flipV="1">
            <a:off x="886932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Straight Connector 1337"/>
          <p:cNvSpPr/>
          <p:nvPr/>
        </p:nvSpPr>
        <p:spPr>
          <a:xfrm flipV="1">
            <a:off x="920592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Straight Connector 1338"/>
          <p:cNvSpPr/>
          <p:nvPr/>
        </p:nvSpPr>
        <p:spPr>
          <a:xfrm flipV="1">
            <a:off x="954252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1339"/>
          <p:cNvSpPr/>
          <p:nvPr/>
        </p:nvSpPr>
        <p:spPr>
          <a:xfrm flipV="1">
            <a:off x="1055520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Straight Connector 1340"/>
          <p:cNvSpPr/>
          <p:nvPr/>
        </p:nvSpPr>
        <p:spPr>
          <a:xfrm flipV="1">
            <a:off x="988056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テキスト ボックス 55"/>
          <p:cNvSpPr/>
          <p:nvPr/>
        </p:nvSpPr>
        <p:spPr>
          <a:xfrm>
            <a:off x="11896560" y="765324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テキスト ボックス 55"/>
          <p:cNvSpPr/>
          <p:nvPr/>
        </p:nvSpPr>
        <p:spPr>
          <a:xfrm>
            <a:off x="1217088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テキスト ボックス 55"/>
          <p:cNvSpPr/>
          <p:nvPr/>
        </p:nvSpPr>
        <p:spPr>
          <a:xfrm>
            <a:off x="1250820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テキスト ボックス 55"/>
          <p:cNvSpPr/>
          <p:nvPr/>
        </p:nvSpPr>
        <p:spPr>
          <a:xfrm>
            <a:off x="1284300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テキスト ボックス 55"/>
          <p:cNvSpPr/>
          <p:nvPr/>
        </p:nvSpPr>
        <p:spPr>
          <a:xfrm>
            <a:off x="1318104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テキスト ボックス 55"/>
          <p:cNvSpPr/>
          <p:nvPr/>
        </p:nvSpPr>
        <p:spPr>
          <a:xfrm>
            <a:off x="1351872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テキスト ボックス 55"/>
          <p:cNvSpPr/>
          <p:nvPr/>
        </p:nvSpPr>
        <p:spPr>
          <a:xfrm>
            <a:off x="1385388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テキスト ボックス 55"/>
          <p:cNvSpPr/>
          <p:nvPr/>
        </p:nvSpPr>
        <p:spPr>
          <a:xfrm>
            <a:off x="14187600" y="76532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Straight Connector 1349"/>
          <p:cNvSpPr/>
          <p:nvPr/>
        </p:nvSpPr>
        <p:spPr>
          <a:xfrm flipV="1">
            <a:off x="1397952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Straight Connector 1350"/>
          <p:cNvSpPr/>
          <p:nvPr/>
        </p:nvSpPr>
        <p:spPr>
          <a:xfrm flipV="1">
            <a:off x="1196172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traight Connector 1351"/>
          <p:cNvSpPr/>
          <p:nvPr/>
        </p:nvSpPr>
        <p:spPr>
          <a:xfrm flipV="1">
            <a:off x="1229832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Straight Connector 1352"/>
          <p:cNvSpPr/>
          <p:nvPr/>
        </p:nvSpPr>
        <p:spPr>
          <a:xfrm flipV="1">
            <a:off x="1263492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Straight Connector 1353"/>
          <p:cNvSpPr/>
          <p:nvPr/>
        </p:nvSpPr>
        <p:spPr>
          <a:xfrm flipV="1">
            <a:off x="1297152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Straight Connector 1354"/>
          <p:cNvSpPr/>
          <p:nvPr/>
        </p:nvSpPr>
        <p:spPr>
          <a:xfrm flipV="1">
            <a:off x="1330632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Straight Connector 1355"/>
          <p:cNvSpPr/>
          <p:nvPr/>
        </p:nvSpPr>
        <p:spPr>
          <a:xfrm flipV="1">
            <a:off x="1431612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Straight Connector 1356"/>
          <p:cNvSpPr/>
          <p:nvPr/>
        </p:nvSpPr>
        <p:spPr>
          <a:xfrm flipV="1">
            <a:off x="1364292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Straight Connector 1357"/>
          <p:cNvSpPr/>
          <p:nvPr/>
        </p:nvSpPr>
        <p:spPr>
          <a:xfrm>
            <a:off x="11555280" y="705024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Straight Connector 1358"/>
          <p:cNvSpPr/>
          <p:nvPr/>
        </p:nvSpPr>
        <p:spPr>
          <a:xfrm>
            <a:off x="11555280" y="741852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テキスト ボックス 55"/>
          <p:cNvSpPr/>
          <p:nvPr/>
        </p:nvSpPr>
        <p:spPr>
          <a:xfrm>
            <a:off x="11073960" y="729468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テキスト ボックス 55"/>
          <p:cNvSpPr/>
          <p:nvPr/>
        </p:nvSpPr>
        <p:spPr>
          <a:xfrm>
            <a:off x="11073960" y="68436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Straight Connector 1361"/>
          <p:cNvSpPr/>
          <p:nvPr/>
        </p:nvSpPr>
        <p:spPr>
          <a:xfrm>
            <a:off x="11555280" y="569268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Straight Connector 1362"/>
          <p:cNvSpPr/>
          <p:nvPr/>
        </p:nvSpPr>
        <p:spPr>
          <a:xfrm>
            <a:off x="11555280" y="614664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Straight Connector 1363"/>
          <p:cNvSpPr/>
          <p:nvPr/>
        </p:nvSpPr>
        <p:spPr>
          <a:xfrm>
            <a:off x="11555280" y="660384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テキスト ボックス 55"/>
          <p:cNvSpPr/>
          <p:nvPr/>
        </p:nvSpPr>
        <p:spPr>
          <a:xfrm>
            <a:off x="11073960" y="64422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テキスト ボックス 55"/>
          <p:cNvSpPr/>
          <p:nvPr/>
        </p:nvSpPr>
        <p:spPr>
          <a:xfrm>
            <a:off x="11073960" y="59911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テキスト ボックス 55"/>
          <p:cNvSpPr/>
          <p:nvPr/>
        </p:nvSpPr>
        <p:spPr>
          <a:xfrm>
            <a:off x="11073960" y="55404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Straight Connector 1367"/>
          <p:cNvSpPr/>
          <p:nvPr/>
        </p:nvSpPr>
        <p:spPr>
          <a:xfrm>
            <a:off x="11555280" y="472140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Straight Connector 1368"/>
          <p:cNvSpPr/>
          <p:nvPr/>
        </p:nvSpPr>
        <p:spPr>
          <a:xfrm>
            <a:off x="11555280" y="516888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テキスト ボックス 55"/>
          <p:cNvSpPr/>
          <p:nvPr/>
        </p:nvSpPr>
        <p:spPr>
          <a:xfrm>
            <a:off x="11073960" y="500688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テキスト ボックス 55"/>
          <p:cNvSpPr/>
          <p:nvPr/>
        </p:nvSpPr>
        <p:spPr>
          <a:xfrm>
            <a:off x="11073960" y="456264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Straight Connector 1371"/>
          <p:cNvSpPr/>
          <p:nvPr/>
        </p:nvSpPr>
        <p:spPr>
          <a:xfrm>
            <a:off x="11555280" y="375912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Straight Connector 1372"/>
          <p:cNvSpPr/>
          <p:nvPr/>
        </p:nvSpPr>
        <p:spPr>
          <a:xfrm>
            <a:off x="11555280" y="421632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テキスト ボックス 55"/>
          <p:cNvSpPr/>
          <p:nvPr/>
        </p:nvSpPr>
        <p:spPr>
          <a:xfrm>
            <a:off x="11073960" y="40543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テキスト ボックス 55"/>
          <p:cNvSpPr/>
          <p:nvPr/>
        </p:nvSpPr>
        <p:spPr>
          <a:xfrm>
            <a:off x="11073960" y="36036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Straight Connector 1375"/>
          <p:cNvSpPr/>
          <p:nvPr/>
        </p:nvSpPr>
        <p:spPr>
          <a:xfrm>
            <a:off x="11555280" y="290052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Straight Connector 1376"/>
          <p:cNvSpPr/>
          <p:nvPr/>
        </p:nvSpPr>
        <p:spPr>
          <a:xfrm>
            <a:off x="11555280" y="335772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テキスト ボックス 55"/>
          <p:cNvSpPr/>
          <p:nvPr/>
        </p:nvSpPr>
        <p:spPr>
          <a:xfrm>
            <a:off x="11073960" y="31957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テキスト ボックス 55"/>
          <p:cNvSpPr/>
          <p:nvPr/>
        </p:nvSpPr>
        <p:spPr>
          <a:xfrm>
            <a:off x="11073960" y="274464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Straight Connector 1379"/>
          <p:cNvSpPr/>
          <p:nvPr/>
        </p:nvSpPr>
        <p:spPr>
          <a:xfrm>
            <a:off x="11547360" y="111744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Straight Connector 1380"/>
          <p:cNvSpPr/>
          <p:nvPr/>
        </p:nvSpPr>
        <p:spPr>
          <a:xfrm>
            <a:off x="11547360" y="156060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Straight Connector 1381"/>
          <p:cNvSpPr/>
          <p:nvPr/>
        </p:nvSpPr>
        <p:spPr>
          <a:xfrm>
            <a:off x="11547360" y="201132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Straight Connector 1382"/>
          <p:cNvSpPr/>
          <p:nvPr/>
        </p:nvSpPr>
        <p:spPr>
          <a:xfrm>
            <a:off x="11547360" y="2468520"/>
            <a:ext cx="92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テキスト ボックス 55"/>
          <p:cNvSpPr/>
          <p:nvPr/>
        </p:nvSpPr>
        <p:spPr>
          <a:xfrm>
            <a:off x="11066040" y="23065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テキスト ボックス 55"/>
          <p:cNvSpPr/>
          <p:nvPr/>
        </p:nvSpPr>
        <p:spPr>
          <a:xfrm>
            <a:off x="11066040" y="18558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テキスト ボックス 55"/>
          <p:cNvSpPr/>
          <p:nvPr/>
        </p:nvSpPr>
        <p:spPr>
          <a:xfrm>
            <a:off x="11066040" y="140508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テキスト ボックス 55"/>
          <p:cNvSpPr/>
          <p:nvPr/>
        </p:nvSpPr>
        <p:spPr>
          <a:xfrm>
            <a:off x="11066040" y="9540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Straight Connector 1387"/>
          <p:cNvSpPr/>
          <p:nvPr/>
        </p:nvSpPr>
        <p:spPr>
          <a:xfrm>
            <a:off x="11547360" y="662040"/>
            <a:ext cx="92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テキスト ボックス 55"/>
          <p:cNvSpPr/>
          <p:nvPr/>
        </p:nvSpPr>
        <p:spPr>
          <a:xfrm>
            <a:off x="11066040" y="51120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Picture 15" descr="D:\N-DSP 2008\DMB-32K.jpg"/>
          <p:cNvPicPr/>
          <p:nvPr/>
        </p:nvPicPr>
        <p:blipFill>
          <a:blip r:embed="rId1"/>
          <a:srcRect l="17891" t="42540" r="40770" b="10256"/>
          <a:stretch/>
        </p:blipFill>
        <p:spPr>
          <a:xfrm>
            <a:off x="7856640" y="3639960"/>
            <a:ext cx="3031920" cy="20210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5" name="Picture 5" descr="D:\N-DSP 2008\DMB-N-DSP.jpg"/>
          <p:cNvPicPr/>
          <p:nvPr/>
        </p:nvPicPr>
        <p:blipFill>
          <a:blip r:embed="rId2"/>
          <a:srcRect l="17891" t="47268" r="40770" b="10256"/>
          <a:stretch/>
        </p:blipFill>
        <p:spPr>
          <a:xfrm>
            <a:off x="7856640" y="5746680"/>
            <a:ext cx="3031920" cy="18925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6" name="Picture 7" descr="D:\N-DSP 2008\DMB-regeant.jpg"/>
          <p:cNvPicPr/>
          <p:nvPr/>
        </p:nvPicPr>
        <p:blipFill>
          <a:blip r:embed="rId3"/>
          <a:srcRect l="17891" t="68722" r="40770" b="14359"/>
          <a:stretch/>
        </p:blipFill>
        <p:spPr>
          <a:xfrm>
            <a:off x="7856640" y="2741760"/>
            <a:ext cx="3031920" cy="7999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7" name="Picture 5" descr="D:\N-DSP 2008\DMB-Sia Std-QA2.jpg"/>
          <p:cNvPicPr/>
          <p:nvPr/>
        </p:nvPicPr>
        <p:blipFill>
          <a:blip r:embed="rId4"/>
          <a:srcRect l="17891" t="34876" r="40770" b="10256"/>
          <a:stretch/>
        </p:blipFill>
        <p:spPr>
          <a:xfrm>
            <a:off x="7856640" y="208080"/>
            <a:ext cx="3031920" cy="24462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8" name="Picture 16" descr="D:\N-DSP 2008\DMB-DPP.jpg"/>
          <p:cNvPicPr/>
          <p:nvPr/>
        </p:nvPicPr>
        <p:blipFill>
          <a:blip r:embed="rId5"/>
          <a:srcRect l="17891" t="72825" r="40770" b="10256"/>
          <a:stretch/>
        </p:blipFill>
        <p:spPr>
          <a:xfrm>
            <a:off x="11620440" y="6885000"/>
            <a:ext cx="3032280" cy="7542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9" name="Picture 11" descr="D:\N-DSP 2008\DMB-DGP.jpg"/>
          <p:cNvPicPr/>
          <p:nvPr/>
        </p:nvPicPr>
        <p:blipFill>
          <a:blip r:embed="rId6"/>
          <a:srcRect l="17891" t="59693" r="40770" b="10256"/>
          <a:stretch/>
        </p:blipFill>
        <p:spPr>
          <a:xfrm>
            <a:off x="11620440" y="5446800"/>
            <a:ext cx="3032280" cy="13399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50" name="Picture 10" descr="D:\N-DSP 2008\DMB-R5-2.jpg"/>
          <p:cNvPicPr/>
          <p:nvPr/>
        </p:nvPicPr>
        <p:blipFill>
          <a:blip r:embed="rId7"/>
          <a:srcRect l="17891" t="49235" r="40770" b="29744"/>
          <a:stretch/>
        </p:blipFill>
        <p:spPr>
          <a:xfrm>
            <a:off x="11620440" y="4454640"/>
            <a:ext cx="3032280" cy="936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51" name="Picture 8" descr="D:\N-DSP 2008\DMB-R4.jpg"/>
          <p:cNvPicPr/>
          <p:nvPr/>
        </p:nvPicPr>
        <p:blipFill>
          <a:blip r:embed="rId8"/>
          <a:srcRect l="17891" t="71799" r="40770" b="10256"/>
          <a:stretch/>
        </p:blipFill>
        <p:spPr>
          <a:xfrm>
            <a:off x="11620440" y="3597120"/>
            <a:ext cx="3032280" cy="8002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52" name="Picture 17" descr="D:\N-DSP 2008\DMB-R3.jpg"/>
          <p:cNvPicPr/>
          <p:nvPr/>
        </p:nvPicPr>
        <p:blipFill>
          <a:blip r:embed="rId9"/>
          <a:srcRect l="17891" t="71799" r="40770" b="10256"/>
          <a:stretch/>
        </p:blipFill>
        <p:spPr>
          <a:xfrm>
            <a:off x="11620440" y="2741760"/>
            <a:ext cx="3032280" cy="7999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53" name="Picture 5" descr="D:\N-DSP 2008\DMB-Sia Std-QA2.jpg"/>
          <p:cNvPicPr/>
          <p:nvPr/>
        </p:nvPicPr>
        <p:blipFill>
          <a:blip r:embed="rId10"/>
          <a:srcRect l="17891" t="34876" r="40770" b="10256"/>
          <a:stretch/>
        </p:blipFill>
        <p:spPr>
          <a:xfrm>
            <a:off x="11620440" y="208080"/>
            <a:ext cx="3032280" cy="24462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154" name="テキスト ボックス 55"/>
          <p:cNvSpPr/>
          <p:nvPr/>
        </p:nvSpPr>
        <p:spPr>
          <a:xfrm>
            <a:off x="14173200" y="6843600"/>
            <a:ext cx="4410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p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テキスト ボックス 42"/>
          <p:cNvSpPr/>
          <p:nvPr/>
        </p:nvSpPr>
        <p:spPr>
          <a:xfrm>
            <a:off x="13818600" y="3597120"/>
            <a:ext cx="794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4-Ds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テキスト ボックス 46"/>
          <p:cNvSpPr/>
          <p:nvPr/>
        </p:nvSpPr>
        <p:spPr>
          <a:xfrm>
            <a:off x="13818600" y="4454640"/>
            <a:ext cx="794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5-Ds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テキスト ボックス 48"/>
          <p:cNvSpPr/>
          <p:nvPr/>
        </p:nvSpPr>
        <p:spPr>
          <a:xfrm>
            <a:off x="14173200" y="5446800"/>
            <a:ext cx="4410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g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テキスト ボックス 42"/>
          <p:cNvSpPr/>
          <p:nvPr/>
        </p:nvSpPr>
        <p:spPr>
          <a:xfrm>
            <a:off x="13818600" y="2741760"/>
            <a:ext cx="794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3-Ds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テキスト ボックス 36"/>
          <p:cNvSpPr/>
          <p:nvPr/>
        </p:nvSpPr>
        <p:spPr>
          <a:xfrm>
            <a:off x="9751320" y="5746680"/>
            <a:ext cx="10980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MW Ds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テキスト ボックス 36"/>
          <p:cNvSpPr/>
          <p:nvPr/>
        </p:nvSpPr>
        <p:spPr>
          <a:xfrm>
            <a:off x="9038880" y="3639960"/>
            <a:ext cx="18068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-kDa Enamel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テキスト ボックス 40"/>
          <p:cNvSpPr/>
          <p:nvPr/>
        </p:nvSpPr>
        <p:spPr>
          <a:xfrm>
            <a:off x="10012320" y="2741760"/>
            <a:ext cx="8344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agen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テキスト ボックス 40"/>
          <p:cNvSpPr/>
          <p:nvPr/>
        </p:nvSpPr>
        <p:spPr>
          <a:xfrm>
            <a:off x="8581680" y="208080"/>
            <a:ext cx="22075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alic Acid Standard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テキスト ボックス 40"/>
          <p:cNvSpPr/>
          <p:nvPr/>
        </p:nvSpPr>
        <p:spPr>
          <a:xfrm>
            <a:off x="12345480" y="208080"/>
            <a:ext cx="22075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alic Acid Standard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Box 791"/>
          <p:cNvSpPr/>
          <p:nvPr/>
        </p:nvSpPr>
        <p:spPr>
          <a:xfrm>
            <a:off x="7416720" y="79200"/>
            <a:ext cx="2368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5" name="Group 792"/>
          <p:cNvGrpSpPr/>
          <p:nvPr/>
        </p:nvGrpSpPr>
        <p:grpSpPr>
          <a:xfrm>
            <a:off x="406080" y="8402760"/>
            <a:ext cx="1405800" cy="1137960"/>
            <a:chOff x="406080" y="8402760"/>
            <a:chExt cx="1405800" cy="1137960"/>
          </a:xfrm>
        </p:grpSpPr>
        <p:sp>
          <p:nvSpPr>
            <p:cNvPr id="166" name="テキスト ボックス 40"/>
            <p:cNvSpPr/>
            <p:nvPr/>
          </p:nvSpPr>
          <p:spPr>
            <a:xfrm>
              <a:off x="406080" y="8788680"/>
              <a:ext cx="14058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MW-DSP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テキスト ボックス 40"/>
            <p:cNvSpPr/>
            <p:nvPr/>
          </p:nvSpPr>
          <p:spPr>
            <a:xfrm>
              <a:off x="412920" y="9174600"/>
              <a:ext cx="10155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5-DSP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テキスト ボックス 40"/>
            <p:cNvSpPr/>
            <p:nvPr/>
          </p:nvSpPr>
          <p:spPr>
            <a:xfrm>
              <a:off x="411840" y="8402760"/>
              <a:ext cx="10857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andard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9" name="Group 796"/>
          <p:cNvGrpSpPr/>
          <p:nvPr/>
        </p:nvGrpSpPr>
        <p:grpSpPr>
          <a:xfrm>
            <a:off x="2182680" y="8016840"/>
            <a:ext cx="1270080" cy="1523880"/>
            <a:chOff x="2182680" y="8016840"/>
            <a:chExt cx="1270080" cy="1523880"/>
          </a:xfrm>
        </p:grpSpPr>
        <p:sp>
          <p:nvSpPr>
            <p:cNvPr id="170" name="テキスト ボックス 40"/>
            <p:cNvSpPr/>
            <p:nvPr/>
          </p:nvSpPr>
          <p:spPr>
            <a:xfrm>
              <a:off x="2182680" y="8016840"/>
              <a:ext cx="12700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µg protein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テキスト ボックス 40"/>
            <p:cNvSpPr/>
            <p:nvPr/>
          </p:nvSpPr>
          <p:spPr>
            <a:xfrm>
              <a:off x="2386800" y="8788680"/>
              <a:ext cx="8618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 µ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テキスト ボックス 40"/>
            <p:cNvSpPr/>
            <p:nvPr/>
          </p:nvSpPr>
          <p:spPr>
            <a:xfrm>
              <a:off x="2386800" y="9174600"/>
              <a:ext cx="8618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70 µ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テキスト ボックス 40"/>
            <p:cNvSpPr/>
            <p:nvPr/>
          </p:nvSpPr>
          <p:spPr>
            <a:xfrm>
              <a:off x="2766240" y="8402760"/>
              <a:ext cx="1029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4" name="Group 801"/>
          <p:cNvGrpSpPr/>
          <p:nvPr/>
        </p:nvGrpSpPr>
        <p:grpSpPr>
          <a:xfrm>
            <a:off x="3840840" y="8016840"/>
            <a:ext cx="1381320" cy="1523880"/>
            <a:chOff x="3840840" y="8016840"/>
            <a:chExt cx="1381320" cy="1523880"/>
          </a:xfrm>
        </p:grpSpPr>
        <p:sp>
          <p:nvSpPr>
            <p:cNvPr id="175" name="テキスト ボックス 40"/>
            <p:cNvSpPr/>
            <p:nvPr/>
          </p:nvSpPr>
          <p:spPr>
            <a:xfrm>
              <a:off x="3840840" y="8016840"/>
              <a:ext cx="1381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rea N-gly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テキスト ボックス 40"/>
            <p:cNvSpPr/>
            <p:nvPr/>
          </p:nvSpPr>
          <p:spPr>
            <a:xfrm>
              <a:off x="3883320" y="8788680"/>
              <a:ext cx="1296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,20704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テキスト ボックス 40"/>
            <p:cNvSpPr/>
            <p:nvPr/>
          </p:nvSpPr>
          <p:spPr>
            <a:xfrm>
              <a:off x="3921120" y="9174600"/>
              <a:ext cx="12200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,229,86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テキスト ボックス 40"/>
            <p:cNvSpPr/>
            <p:nvPr/>
          </p:nvSpPr>
          <p:spPr>
            <a:xfrm>
              <a:off x="3921120" y="8402760"/>
              <a:ext cx="12200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,720,819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9" name="Group 806"/>
          <p:cNvGrpSpPr/>
          <p:nvPr/>
        </p:nvGrpSpPr>
        <p:grpSpPr>
          <a:xfrm>
            <a:off x="5607360" y="8016840"/>
            <a:ext cx="686520" cy="1523880"/>
            <a:chOff x="5607360" y="8016840"/>
            <a:chExt cx="686520" cy="1523880"/>
          </a:xfrm>
        </p:grpSpPr>
        <p:sp>
          <p:nvSpPr>
            <p:cNvPr id="180" name="テキスト ボックス 40"/>
            <p:cNvSpPr/>
            <p:nvPr/>
          </p:nvSpPr>
          <p:spPr>
            <a:xfrm>
              <a:off x="5636160" y="8016840"/>
              <a:ext cx="6285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mo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テキスト ボックス 40"/>
            <p:cNvSpPr/>
            <p:nvPr/>
          </p:nvSpPr>
          <p:spPr>
            <a:xfrm>
              <a:off x="5607360" y="8788680"/>
              <a:ext cx="6865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.16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テキスト ボックス 40"/>
            <p:cNvSpPr/>
            <p:nvPr/>
          </p:nvSpPr>
          <p:spPr>
            <a:xfrm>
              <a:off x="5607360" y="9174600"/>
              <a:ext cx="6865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.2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テキスト ボックス 40"/>
            <p:cNvSpPr/>
            <p:nvPr/>
          </p:nvSpPr>
          <p:spPr>
            <a:xfrm>
              <a:off x="5797440" y="8402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4" name="Group 811"/>
          <p:cNvGrpSpPr/>
          <p:nvPr/>
        </p:nvGrpSpPr>
        <p:grpSpPr>
          <a:xfrm>
            <a:off x="9870120" y="8016840"/>
            <a:ext cx="1090440" cy="1523880"/>
            <a:chOff x="9870120" y="8016840"/>
            <a:chExt cx="1090440" cy="1523880"/>
          </a:xfrm>
        </p:grpSpPr>
        <p:sp>
          <p:nvSpPr>
            <p:cNvPr id="185" name="テキスト ボックス 40"/>
            <p:cNvSpPr/>
            <p:nvPr/>
          </p:nvSpPr>
          <p:spPr>
            <a:xfrm>
              <a:off x="9975240" y="8016840"/>
              <a:ext cx="8802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µg Sia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テキスト ボックス 40"/>
            <p:cNvSpPr/>
            <p:nvPr/>
          </p:nvSpPr>
          <p:spPr>
            <a:xfrm>
              <a:off x="9870120" y="8788680"/>
              <a:ext cx="10904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6.96 µ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テキスト ボックス 40"/>
            <p:cNvSpPr/>
            <p:nvPr/>
          </p:nvSpPr>
          <p:spPr>
            <a:xfrm>
              <a:off x="9870120" y="9174600"/>
              <a:ext cx="10904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.48 µ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テキスト ボックス 40"/>
            <p:cNvSpPr/>
            <p:nvPr/>
          </p:nvSpPr>
          <p:spPr>
            <a:xfrm>
              <a:off x="10060560" y="8402760"/>
              <a:ext cx="7095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 µ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9" name="Group 816"/>
          <p:cNvGrpSpPr/>
          <p:nvPr/>
        </p:nvGrpSpPr>
        <p:grpSpPr>
          <a:xfrm>
            <a:off x="11338560" y="8016840"/>
            <a:ext cx="1390680" cy="1523880"/>
            <a:chOff x="11338560" y="8016840"/>
            <a:chExt cx="1390680" cy="1523880"/>
          </a:xfrm>
        </p:grpSpPr>
        <p:sp>
          <p:nvSpPr>
            <p:cNvPr id="190" name="テキスト ボックス 40"/>
            <p:cNvSpPr/>
            <p:nvPr/>
          </p:nvSpPr>
          <p:spPr>
            <a:xfrm>
              <a:off x="11443680" y="8016840"/>
              <a:ext cx="11804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mol Sia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テキスト ボックス 40"/>
            <p:cNvSpPr/>
            <p:nvPr/>
          </p:nvSpPr>
          <p:spPr>
            <a:xfrm>
              <a:off x="11338560" y="8788680"/>
              <a:ext cx="13906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4.83 nmo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テキスト ボックス 40"/>
            <p:cNvSpPr/>
            <p:nvPr/>
          </p:nvSpPr>
          <p:spPr>
            <a:xfrm>
              <a:off x="11338560" y="9174600"/>
              <a:ext cx="13906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3.89 nmo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テキスト ボックス 40"/>
            <p:cNvSpPr/>
            <p:nvPr/>
          </p:nvSpPr>
          <p:spPr>
            <a:xfrm>
              <a:off x="11338560" y="8402760"/>
              <a:ext cx="13906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.42 nmo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4" name="Group 821"/>
          <p:cNvGrpSpPr/>
          <p:nvPr/>
        </p:nvGrpSpPr>
        <p:grpSpPr>
          <a:xfrm>
            <a:off x="8221320" y="8016840"/>
            <a:ext cx="1270080" cy="1523880"/>
            <a:chOff x="8221320" y="8016840"/>
            <a:chExt cx="1270080" cy="1523880"/>
          </a:xfrm>
        </p:grpSpPr>
        <p:sp>
          <p:nvSpPr>
            <p:cNvPr id="195" name="テキスト ボックス 40"/>
            <p:cNvSpPr/>
            <p:nvPr/>
          </p:nvSpPr>
          <p:spPr>
            <a:xfrm>
              <a:off x="8221320" y="8016840"/>
              <a:ext cx="12700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µg protein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テキスト ボックス 40"/>
            <p:cNvSpPr/>
            <p:nvPr/>
          </p:nvSpPr>
          <p:spPr>
            <a:xfrm>
              <a:off x="8425440" y="8788680"/>
              <a:ext cx="8618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70 µ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テキスト ボックス 40"/>
            <p:cNvSpPr/>
            <p:nvPr/>
          </p:nvSpPr>
          <p:spPr>
            <a:xfrm>
              <a:off x="8425440" y="9174600"/>
              <a:ext cx="8618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60 µ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テキスト ボックス 40"/>
            <p:cNvSpPr/>
            <p:nvPr/>
          </p:nvSpPr>
          <p:spPr>
            <a:xfrm>
              <a:off x="8425440" y="8402760"/>
              <a:ext cx="8618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50 µ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9" name="Group 826"/>
          <p:cNvGrpSpPr/>
          <p:nvPr/>
        </p:nvGrpSpPr>
        <p:grpSpPr>
          <a:xfrm>
            <a:off x="15754680" y="8016840"/>
            <a:ext cx="1858320" cy="1523880"/>
            <a:chOff x="15754680" y="8016840"/>
            <a:chExt cx="1858320" cy="1523880"/>
          </a:xfrm>
        </p:grpSpPr>
        <p:sp>
          <p:nvSpPr>
            <p:cNvPr id="200" name="テキスト ボックス 40"/>
            <p:cNvSpPr/>
            <p:nvPr/>
          </p:nvSpPr>
          <p:spPr>
            <a:xfrm>
              <a:off x="15932880" y="8016840"/>
              <a:ext cx="1501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 Sial/N-gly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テキスト ボックス 40"/>
            <p:cNvSpPr/>
            <p:nvPr/>
          </p:nvSpPr>
          <p:spPr>
            <a:xfrm>
              <a:off x="15754680" y="8788680"/>
              <a:ext cx="1858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7.3/13.6 = 1.3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テキスト ボックス 40"/>
            <p:cNvSpPr/>
            <p:nvPr/>
          </p:nvSpPr>
          <p:spPr>
            <a:xfrm>
              <a:off x="15983280" y="9174600"/>
              <a:ext cx="1401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.6/9.2=0.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テキスト ボックス 40"/>
            <p:cNvSpPr/>
            <p:nvPr/>
          </p:nvSpPr>
          <p:spPr>
            <a:xfrm>
              <a:off x="16632360" y="8402760"/>
              <a:ext cx="1029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4" name="Group 831"/>
          <p:cNvGrpSpPr/>
          <p:nvPr/>
        </p:nvGrpSpPr>
        <p:grpSpPr>
          <a:xfrm>
            <a:off x="6675480" y="8016840"/>
            <a:ext cx="1162080" cy="1523880"/>
            <a:chOff x="6675480" y="8016840"/>
            <a:chExt cx="1162080" cy="1523880"/>
          </a:xfrm>
        </p:grpSpPr>
        <p:sp>
          <p:nvSpPr>
            <p:cNvPr id="205" name="テキスト ボックス 40"/>
            <p:cNvSpPr/>
            <p:nvPr/>
          </p:nvSpPr>
          <p:spPr>
            <a:xfrm>
              <a:off x="6675480" y="8016840"/>
              <a:ext cx="11620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dj nmo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テキスト ボックス 40"/>
            <p:cNvSpPr/>
            <p:nvPr/>
          </p:nvSpPr>
          <p:spPr>
            <a:xfrm>
              <a:off x="6989400" y="8788680"/>
              <a:ext cx="5342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3.6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テキスト ボックス 40"/>
            <p:cNvSpPr/>
            <p:nvPr/>
          </p:nvSpPr>
          <p:spPr>
            <a:xfrm>
              <a:off x="7065360" y="9174600"/>
              <a:ext cx="3816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.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テキスト ボックス 40"/>
            <p:cNvSpPr/>
            <p:nvPr/>
          </p:nvSpPr>
          <p:spPr>
            <a:xfrm>
              <a:off x="7205040" y="8402760"/>
              <a:ext cx="1029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9" name="Group 836"/>
          <p:cNvGrpSpPr/>
          <p:nvPr/>
        </p:nvGrpSpPr>
        <p:grpSpPr>
          <a:xfrm>
            <a:off x="13112280" y="8016840"/>
            <a:ext cx="2257920" cy="1523880"/>
            <a:chOff x="13112280" y="8016840"/>
            <a:chExt cx="2257920" cy="1523880"/>
          </a:xfrm>
        </p:grpSpPr>
        <p:sp>
          <p:nvSpPr>
            <p:cNvPr id="210" name="テキスト ボックス 40"/>
            <p:cNvSpPr/>
            <p:nvPr/>
          </p:nvSpPr>
          <p:spPr>
            <a:xfrm>
              <a:off x="13384440" y="8016840"/>
              <a:ext cx="17136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dj nmol Sia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テキスト ボックス 40"/>
            <p:cNvSpPr/>
            <p:nvPr/>
          </p:nvSpPr>
          <p:spPr>
            <a:xfrm>
              <a:off x="13112280" y="8788680"/>
              <a:ext cx="2257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x18/57=17.3 nmo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テキスト ボックス 40"/>
            <p:cNvSpPr/>
            <p:nvPr/>
          </p:nvSpPr>
          <p:spPr>
            <a:xfrm>
              <a:off x="13188600" y="9174600"/>
              <a:ext cx="21052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x17/76=7.6 nmo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テキスト ボックス 40"/>
            <p:cNvSpPr/>
            <p:nvPr/>
          </p:nvSpPr>
          <p:spPr>
            <a:xfrm>
              <a:off x="14189760" y="8402760"/>
              <a:ext cx="1029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4" name="テキスト ボックス 40"/>
          <p:cNvSpPr/>
          <p:nvPr/>
        </p:nvSpPr>
        <p:spPr>
          <a:xfrm>
            <a:off x="137520" y="8066160"/>
            <a:ext cx="2566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テキスト ボックス 66"/>
          <p:cNvSpPr/>
          <p:nvPr/>
        </p:nvSpPr>
        <p:spPr>
          <a:xfrm>
            <a:off x="8245080" y="52848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テキスト ボックス 66"/>
          <p:cNvSpPr/>
          <p:nvPr/>
        </p:nvSpPr>
        <p:spPr>
          <a:xfrm>
            <a:off x="12021840" y="52848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テキスト ボックス 66"/>
          <p:cNvSpPr/>
          <p:nvPr/>
        </p:nvSpPr>
        <p:spPr>
          <a:xfrm>
            <a:off x="8575560" y="46044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テキスト ボックス 66"/>
          <p:cNvSpPr/>
          <p:nvPr/>
        </p:nvSpPr>
        <p:spPr>
          <a:xfrm>
            <a:off x="12352320" y="46044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テキスト ボックス 66"/>
          <p:cNvSpPr/>
          <p:nvPr/>
        </p:nvSpPr>
        <p:spPr>
          <a:xfrm>
            <a:off x="8938080" y="119556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テキスト ボックス 66"/>
          <p:cNvSpPr/>
          <p:nvPr/>
        </p:nvSpPr>
        <p:spPr>
          <a:xfrm>
            <a:off x="12714480" y="119556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テキスト ボックス 66"/>
          <p:cNvSpPr/>
          <p:nvPr/>
        </p:nvSpPr>
        <p:spPr>
          <a:xfrm>
            <a:off x="9536040" y="48276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テキスト ボックス 66"/>
          <p:cNvSpPr/>
          <p:nvPr/>
        </p:nvSpPr>
        <p:spPr>
          <a:xfrm>
            <a:off x="13312800" y="48276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テキスト ボックス 66"/>
          <p:cNvSpPr/>
          <p:nvPr/>
        </p:nvSpPr>
        <p:spPr>
          <a:xfrm>
            <a:off x="9731880" y="43668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テキスト ボックス 66"/>
          <p:cNvSpPr/>
          <p:nvPr/>
        </p:nvSpPr>
        <p:spPr>
          <a:xfrm>
            <a:off x="13508280" y="43668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テキスト ボックス 66"/>
          <p:cNvSpPr/>
          <p:nvPr/>
        </p:nvSpPr>
        <p:spPr>
          <a:xfrm>
            <a:off x="10099440" y="1685880"/>
            <a:ext cx="86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テキスト ボックス 66"/>
          <p:cNvSpPr/>
          <p:nvPr/>
        </p:nvSpPr>
        <p:spPr>
          <a:xfrm>
            <a:off x="13876200" y="1685880"/>
            <a:ext cx="86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1472"/>
          <p:cNvSpPr/>
          <p:nvPr/>
        </p:nvSpPr>
        <p:spPr>
          <a:xfrm>
            <a:off x="60480" y="8043840"/>
            <a:ext cx="17633880" cy="1555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8" name="Picture 2" descr="D:\Sialic acid analysis\Sia-std  buffer effect.jpg"/>
          <p:cNvPicPr/>
          <p:nvPr/>
        </p:nvPicPr>
        <p:blipFill>
          <a:blip r:embed="rId11"/>
          <a:srcRect l="20571" t="37949" r="33662" b="11282"/>
          <a:stretch/>
        </p:blipFill>
        <p:spPr>
          <a:xfrm>
            <a:off x="14770080" y="208080"/>
            <a:ext cx="2906640" cy="19605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229" name="テキスト ボックス 14"/>
          <p:cNvSpPr/>
          <p:nvPr/>
        </p:nvSpPr>
        <p:spPr>
          <a:xfrm>
            <a:off x="17076240" y="576360"/>
            <a:ext cx="567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c00000"/>
                </a:solidFill>
                <a:latin typeface="Times New Roman"/>
                <a:ea typeface="Times New Roman"/>
              </a:rPr>
              <a:t>Fres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0" name="Picture 5" descr="D:\Sialic acid analysis\Sia-32k raw 052410-2.jpg"/>
          <p:cNvPicPr/>
          <p:nvPr/>
        </p:nvPicPr>
        <p:blipFill>
          <a:blip r:embed="rId12"/>
          <a:srcRect l="20465" t="16317" r="33490" b="25496"/>
          <a:stretch/>
        </p:blipFill>
        <p:spPr>
          <a:xfrm>
            <a:off x="14773320" y="2246400"/>
            <a:ext cx="2914560" cy="27734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231" name="テキスト ボックス 34"/>
          <p:cNvSpPr/>
          <p:nvPr/>
        </p:nvSpPr>
        <p:spPr>
          <a:xfrm>
            <a:off x="16641720" y="208080"/>
            <a:ext cx="10508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90"/>
                </a:solidFill>
                <a:latin typeface="Times New Roman"/>
                <a:ea typeface="Times New Roman"/>
              </a:rPr>
              <a:t>2 days ol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テキスト ボックス 55"/>
          <p:cNvSpPr/>
          <p:nvPr/>
        </p:nvSpPr>
        <p:spPr>
          <a:xfrm>
            <a:off x="15016320" y="7653240"/>
            <a:ext cx="180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テキスト ボックス 55"/>
          <p:cNvSpPr/>
          <p:nvPr/>
        </p:nvSpPr>
        <p:spPr>
          <a:xfrm>
            <a:off x="15249600" y="7653240"/>
            <a:ext cx="36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テキスト ボックス 55"/>
          <p:cNvSpPr/>
          <p:nvPr/>
        </p:nvSpPr>
        <p:spPr>
          <a:xfrm>
            <a:off x="15576480" y="7653240"/>
            <a:ext cx="3621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テキスト ボックス 55"/>
          <p:cNvSpPr/>
          <p:nvPr/>
        </p:nvSpPr>
        <p:spPr>
          <a:xfrm>
            <a:off x="15901920" y="7653240"/>
            <a:ext cx="3621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テキスト ボックス 55"/>
          <p:cNvSpPr/>
          <p:nvPr/>
        </p:nvSpPr>
        <p:spPr>
          <a:xfrm>
            <a:off x="16232040" y="7653240"/>
            <a:ext cx="36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テキスト ボックス 55"/>
          <p:cNvSpPr/>
          <p:nvPr/>
        </p:nvSpPr>
        <p:spPr>
          <a:xfrm>
            <a:off x="16549560" y="7653240"/>
            <a:ext cx="36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テキスト ボックス 55"/>
          <p:cNvSpPr/>
          <p:nvPr/>
        </p:nvSpPr>
        <p:spPr>
          <a:xfrm>
            <a:off x="16867080" y="7653240"/>
            <a:ext cx="3621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テキスト ボックス 55"/>
          <p:cNvSpPr/>
          <p:nvPr/>
        </p:nvSpPr>
        <p:spPr>
          <a:xfrm>
            <a:off x="17191080" y="7653240"/>
            <a:ext cx="3618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Straight Connector 1485"/>
          <p:cNvSpPr/>
          <p:nvPr/>
        </p:nvSpPr>
        <p:spPr>
          <a:xfrm flipV="1">
            <a:off x="1704960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Straight Connector 1486"/>
          <p:cNvSpPr/>
          <p:nvPr/>
        </p:nvSpPr>
        <p:spPr>
          <a:xfrm flipV="1">
            <a:off x="15100200" y="7600680"/>
            <a:ext cx="32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Straight Connector 1487"/>
          <p:cNvSpPr/>
          <p:nvPr/>
        </p:nvSpPr>
        <p:spPr>
          <a:xfrm flipV="1">
            <a:off x="1543068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Straight Connector 1488"/>
          <p:cNvSpPr/>
          <p:nvPr/>
        </p:nvSpPr>
        <p:spPr>
          <a:xfrm flipV="1">
            <a:off x="1575288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Straight Connector 1489"/>
          <p:cNvSpPr/>
          <p:nvPr/>
        </p:nvSpPr>
        <p:spPr>
          <a:xfrm flipV="1">
            <a:off x="16081200" y="760068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Straight Connector 1490"/>
          <p:cNvSpPr/>
          <p:nvPr/>
        </p:nvSpPr>
        <p:spPr>
          <a:xfrm flipV="1">
            <a:off x="16409880" y="7600680"/>
            <a:ext cx="32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Straight Connector 1491"/>
          <p:cNvSpPr/>
          <p:nvPr/>
        </p:nvSpPr>
        <p:spPr>
          <a:xfrm flipV="1">
            <a:off x="17372160" y="760068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Straight Connector 1492"/>
          <p:cNvSpPr/>
          <p:nvPr/>
        </p:nvSpPr>
        <p:spPr>
          <a:xfrm flipV="1">
            <a:off x="16725960" y="7600680"/>
            <a:ext cx="32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8" name="Picture 2" descr="D:\Sialic acid analysis\Sia-Std(Glyko)+32K 052310.jpg"/>
          <p:cNvPicPr/>
          <p:nvPr/>
        </p:nvPicPr>
        <p:blipFill>
          <a:blip r:embed="rId13"/>
          <a:srcRect l="20571" t="33846" r="33662" b="13333"/>
          <a:stretch/>
        </p:blipFill>
        <p:spPr>
          <a:xfrm>
            <a:off x="14770080" y="5097600"/>
            <a:ext cx="2913120" cy="25416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249" name="テキスト ボックス 36"/>
          <p:cNvSpPr/>
          <p:nvPr/>
        </p:nvSpPr>
        <p:spPr>
          <a:xfrm>
            <a:off x="15776280" y="2279520"/>
            <a:ext cx="18068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-kDa Enamel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テキスト ボックス 36"/>
          <p:cNvSpPr/>
          <p:nvPr/>
        </p:nvSpPr>
        <p:spPr>
          <a:xfrm>
            <a:off x="16098840" y="5160960"/>
            <a:ext cx="1538280" cy="61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-kDa +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resh Standar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テキスト ボックス 66"/>
          <p:cNvSpPr/>
          <p:nvPr/>
        </p:nvSpPr>
        <p:spPr>
          <a:xfrm>
            <a:off x="15466680" y="630252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テキスト ボックス 66"/>
          <p:cNvSpPr/>
          <p:nvPr/>
        </p:nvSpPr>
        <p:spPr>
          <a:xfrm>
            <a:off x="15827400" y="519444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テキスト ボックス 66"/>
          <p:cNvSpPr/>
          <p:nvPr/>
        </p:nvSpPr>
        <p:spPr>
          <a:xfrm>
            <a:off x="16088040" y="675180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テキスト ボックス 66"/>
          <p:cNvSpPr/>
          <p:nvPr/>
        </p:nvSpPr>
        <p:spPr>
          <a:xfrm>
            <a:off x="16714800" y="62118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テキスト ボックス 66"/>
          <p:cNvSpPr/>
          <p:nvPr/>
        </p:nvSpPr>
        <p:spPr>
          <a:xfrm>
            <a:off x="16939800" y="681516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テキスト ボックス 66"/>
          <p:cNvSpPr/>
          <p:nvPr/>
        </p:nvSpPr>
        <p:spPr>
          <a:xfrm>
            <a:off x="17350200" y="6953400"/>
            <a:ext cx="86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Box 884"/>
          <p:cNvSpPr/>
          <p:nvPr/>
        </p:nvSpPr>
        <p:spPr>
          <a:xfrm>
            <a:off x="14779800" y="210960"/>
            <a:ext cx="416880" cy="473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8" name="Group 885"/>
          <p:cNvGrpSpPr/>
          <p:nvPr/>
        </p:nvGrpSpPr>
        <p:grpSpPr>
          <a:xfrm>
            <a:off x="50760" y="79200"/>
            <a:ext cx="7105680" cy="7879680"/>
            <a:chOff x="50760" y="79200"/>
            <a:chExt cx="7105680" cy="7879680"/>
          </a:xfrm>
        </p:grpSpPr>
        <p:grpSp>
          <p:nvGrpSpPr>
            <p:cNvPr id="259" name="Group 823"/>
            <p:cNvGrpSpPr/>
            <p:nvPr/>
          </p:nvGrpSpPr>
          <p:grpSpPr>
            <a:xfrm>
              <a:off x="482760" y="7610400"/>
              <a:ext cx="6523920" cy="348480"/>
              <a:chOff x="482760" y="7610400"/>
              <a:chExt cx="6523920" cy="348480"/>
            </a:xfrm>
          </p:grpSpPr>
          <p:grpSp>
            <p:nvGrpSpPr>
              <p:cNvPr id="260" name="Group 1112"/>
              <p:cNvGrpSpPr/>
              <p:nvPr/>
            </p:nvGrpSpPr>
            <p:grpSpPr>
              <a:xfrm>
                <a:off x="3916440" y="7610400"/>
                <a:ext cx="3090240" cy="348480"/>
                <a:chOff x="3916440" y="7610400"/>
                <a:chExt cx="3090240" cy="348480"/>
              </a:xfrm>
            </p:grpSpPr>
            <p:sp>
              <p:nvSpPr>
                <p:cNvPr id="261" name="Straight Connector 1583"/>
                <p:cNvSpPr/>
                <p:nvPr/>
              </p:nvSpPr>
              <p:spPr>
                <a:xfrm flipV="1">
                  <a:off x="470808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Straight Connector 1584"/>
                <p:cNvSpPr/>
                <p:nvPr/>
              </p:nvSpPr>
              <p:spPr>
                <a:xfrm flipV="1">
                  <a:off x="542412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Straight Connector 1585"/>
                <p:cNvSpPr/>
                <p:nvPr/>
              </p:nvSpPr>
              <p:spPr>
                <a:xfrm flipV="1">
                  <a:off x="615456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Straight Connector 1586"/>
                <p:cNvSpPr/>
                <p:nvPr/>
              </p:nvSpPr>
              <p:spPr>
                <a:xfrm flipV="1">
                  <a:off x="397800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Straight Connector 1587"/>
                <p:cNvSpPr/>
                <p:nvPr/>
              </p:nvSpPr>
              <p:spPr>
                <a:xfrm flipV="1">
                  <a:off x="687384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テキスト ボックス 66"/>
                <p:cNvSpPr/>
                <p:nvPr/>
              </p:nvSpPr>
              <p:spPr>
                <a:xfrm>
                  <a:off x="3916440" y="7653600"/>
                  <a:ext cx="1288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6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テキスト ボックス 66"/>
                <p:cNvSpPr/>
                <p:nvPr/>
              </p:nvSpPr>
              <p:spPr>
                <a:xfrm>
                  <a:off x="4644360" y="7653600"/>
                  <a:ext cx="1288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9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テキスト ボックス 66"/>
                <p:cNvSpPr/>
                <p:nvPr/>
              </p:nvSpPr>
              <p:spPr>
                <a:xfrm>
                  <a:off x="5299560" y="7653600"/>
                  <a:ext cx="2566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2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テキスト ボックス 66"/>
                <p:cNvSpPr/>
                <p:nvPr/>
              </p:nvSpPr>
              <p:spPr>
                <a:xfrm>
                  <a:off x="6026400" y="7653600"/>
                  <a:ext cx="2566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5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テキスト ボックス 66"/>
                <p:cNvSpPr/>
                <p:nvPr/>
              </p:nvSpPr>
              <p:spPr>
                <a:xfrm>
                  <a:off x="6750000" y="7653600"/>
                  <a:ext cx="2566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8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71" name="Group 1280"/>
              <p:cNvGrpSpPr/>
              <p:nvPr/>
            </p:nvGrpSpPr>
            <p:grpSpPr>
              <a:xfrm>
                <a:off x="482760" y="7610400"/>
                <a:ext cx="3090240" cy="348480"/>
                <a:chOff x="482760" y="7610400"/>
                <a:chExt cx="3090240" cy="348480"/>
              </a:xfrm>
            </p:grpSpPr>
            <p:sp>
              <p:nvSpPr>
                <p:cNvPr id="272" name="Straight Connector 1573"/>
                <p:cNvSpPr/>
                <p:nvPr/>
              </p:nvSpPr>
              <p:spPr>
                <a:xfrm flipV="1">
                  <a:off x="127440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Straight Connector 1574"/>
                <p:cNvSpPr/>
                <p:nvPr/>
              </p:nvSpPr>
              <p:spPr>
                <a:xfrm flipV="1">
                  <a:off x="199044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Straight Connector 1575"/>
                <p:cNvSpPr/>
                <p:nvPr/>
              </p:nvSpPr>
              <p:spPr>
                <a:xfrm flipV="1">
                  <a:off x="272088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Straight Connector 1576"/>
                <p:cNvSpPr/>
                <p:nvPr/>
              </p:nvSpPr>
              <p:spPr>
                <a:xfrm flipV="1">
                  <a:off x="54396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Straight Connector 1577"/>
                <p:cNvSpPr/>
                <p:nvPr/>
              </p:nvSpPr>
              <p:spPr>
                <a:xfrm flipV="1">
                  <a:off x="3439800" y="7610400"/>
                  <a:ext cx="1440" cy="90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2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テキスト ボックス 66"/>
                <p:cNvSpPr/>
                <p:nvPr/>
              </p:nvSpPr>
              <p:spPr>
                <a:xfrm>
                  <a:off x="482760" y="7653600"/>
                  <a:ext cx="1288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6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テキスト ボックス 66"/>
                <p:cNvSpPr/>
                <p:nvPr/>
              </p:nvSpPr>
              <p:spPr>
                <a:xfrm>
                  <a:off x="1210680" y="7653600"/>
                  <a:ext cx="1288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9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テキスト ボックス 66"/>
                <p:cNvSpPr/>
                <p:nvPr/>
              </p:nvSpPr>
              <p:spPr>
                <a:xfrm>
                  <a:off x="1865880" y="7653600"/>
                  <a:ext cx="2566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2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テキスト ボックス 66"/>
                <p:cNvSpPr/>
                <p:nvPr/>
              </p:nvSpPr>
              <p:spPr>
                <a:xfrm>
                  <a:off x="2592720" y="7653600"/>
                  <a:ext cx="2566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5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テキスト ボックス 66"/>
                <p:cNvSpPr/>
                <p:nvPr/>
              </p:nvSpPr>
              <p:spPr>
                <a:xfrm>
                  <a:off x="3316320" y="7653600"/>
                  <a:ext cx="256680" cy="305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619200"/>
                      <a:tab algn="l" pos="1238400"/>
                      <a:tab algn="l" pos="1857240"/>
                      <a:tab algn="l" pos="2476440"/>
                      <a:tab algn="l" pos="3095640"/>
                      <a:tab algn="l" pos="3714840"/>
                      <a:tab algn="l" pos="4334040"/>
                      <a:tab algn="l" pos="4952880"/>
                      <a:tab algn="l" pos="5572080"/>
                      <a:tab algn="l" pos="6191280"/>
                      <a:tab algn="l" pos="6810480"/>
                      <a:tab algn="l" pos="7429680"/>
                      <a:tab algn="l" pos="8048520"/>
                      <a:tab algn="l" pos="8667720"/>
                      <a:tab algn="l" pos="9286920"/>
                      <a:tab algn="l" pos="9906120"/>
                      <a:tab algn="l" pos="1052496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8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82" name="Straight Connector 1505"/>
            <p:cNvSpPr/>
            <p:nvPr/>
          </p:nvSpPr>
          <p:spPr>
            <a:xfrm>
              <a:off x="390240" y="749952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Straight Connector 1506"/>
            <p:cNvSpPr/>
            <p:nvPr/>
          </p:nvSpPr>
          <p:spPr>
            <a:xfrm>
              <a:off x="390240" y="698688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Straight Connector 1507"/>
            <p:cNvSpPr/>
            <p:nvPr/>
          </p:nvSpPr>
          <p:spPr>
            <a:xfrm>
              <a:off x="390240" y="647568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Straight Connector 1508"/>
            <p:cNvSpPr/>
            <p:nvPr/>
          </p:nvSpPr>
          <p:spPr>
            <a:xfrm>
              <a:off x="390240" y="582948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Straight Connector 1509"/>
            <p:cNvSpPr/>
            <p:nvPr/>
          </p:nvSpPr>
          <p:spPr>
            <a:xfrm>
              <a:off x="390240" y="529920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Straight Connector 1510"/>
            <p:cNvSpPr/>
            <p:nvPr/>
          </p:nvSpPr>
          <p:spPr>
            <a:xfrm>
              <a:off x="390240" y="477036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Straight Connector 1511"/>
            <p:cNvSpPr/>
            <p:nvPr/>
          </p:nvSpPr>
          <p:spPr>
            <a:xfrm>
              <a:off x="390240" y="257148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Straight Connector 1512"/>
            <p:cNvSpPr/>
            <p:nvPr/>
          </p:nvSpPr>
          <p:spPr>
            <a:xfrm>
              <a:off x="390240" y="203508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Straight Connector 1513"/>
            <p:cNvSpPr/>
            <p:nvPr/>
          </p:nvSpPr>
          <p:spPr>
            <a:xfrm>
              <a:off x="390240" y="150480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Straight Connector 1514"/>
            <p:cNvSpPr/>
            <p:nvPr/>
          </p:nvSpPr>
          <p:spPr>
            <a:xfrm>
              <a:off x="390240" y="421308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Straight Connector 1515"/>
            <p:cNvSpPr/>
            <p:nvPr/>
          </p:nvSpPr>
          <p:spPr>
            <a:xfrm>
              <a:off x="390240" y="373356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Straight Connector 1516"/>
            <p:cNvSpPr/>
            <p:nvPr/>
          </p:nvSpPr>
          <p:spPr>
            <a:xfrm>
              <a:off x="390240" y="325116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Straight Connector 1517"/>
            <p:cNvSpPr/>
            <p:nvPr/>
          </p:nvSpPr>
          <p:spPr>
            <a:xfrm>
              <a:off x="390240" y="95868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Straight Connector 1518"/>
            <p:cNvSpPr/>
            <p:nvPr/>
          </p:nvSpPr>
          <p:spPr>
            <a:xfrm>
              <a:off x="390240" y="641160"/>
              <a:ext cx="9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テキスト ボックス 66"/>
            <p:cNvSpPr/>
            <p:nvPr/>
          </p:nvSpPr>
          <p:spPr>
            <a:xfrm>
              <a:off x="50760" y="631476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2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テキスト ボックス 66"/>
            <p:cNvSpPr/>
            <p:nvPr/>
          </p:nvSpPr>
          <p:spPr>
            <a:xfrm>
              <a:off x="50760" y="734508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テキスト ボックス 66"/>
            <p:cNvSpPr/>
            <p:nvPr/>
          </p:nvSpPr>
          <p:spPr>
            <a:xfrm>
              <a:off x="50760" y="682992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テキスト ボックス 66"/>
            <p:cNvSpPr/>
            <p:nvPr/>
          </p:nvSpPr>
          <p:spPr>
            <a:xfrm>
              <a:off x="50760" y="461052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2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テキスト ボックス 66"/>
            <p:cNvSpPr/>
            <p:nvPr/>
          </p:nvSpPr>
          <p:spPr>
            <a:xfrm>
              <a:off x="50760" y="567576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テキスト ボックス 66"/>
            <p:cNvSpPr/>
            <p:nvPr/>
          </p:nvSpPr>
          <p:spPr>
            <a:xfrm>
              <a:off x="50760" y="514152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テキスト ボックス 66"/>
            <p:cNvSpPr/>
            <p:nvPr/>
          </p:nvSpPr>
          <p:spPr>
            <a:xfrm>
              <a:off x="50760" y="308988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2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テキスト ボックス 66"/>
            <p:cNvSpPr/>
            <p:nvPr/>
          </p:nvSpPr>
          <p:spPr>
            <a:xfrm>
              <a:off x="50760" y="405972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テキスト ボックス 66"/>
            <p:cNvSpPr/>
            <p:nvPr/>
          </p:nvSpPr>
          <p:spPr>
            <a:xfrm>
              <a:off x="50760" y="357624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テキスト ボックス 66"/>
            <p:cNvSpPr/>
            <p:nvPr/>
          </p:nvSpPr>
          <p:spPr>
            <a:xfrm>
              <a:off x="50760" y="134352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2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テキスト ボックス 66"/>
            <p:cNvSpPr/>
            <p:nvPr/>
          </p:nvSpPr>
          <p:spPr>
            <a:xfrm>
              <a:off x="50760" y="241812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テキスト ボックス 66"/>
            <p:cNvSpPr/>
            <p:nvPr/>
          </p:nvSpPr>
          <p:spPr>
            <a:xfrm>
              <a:off x="50760" y="187776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テキスト ボックス 66"/>
            <p:cNvSpPr/>
            <p:nvPr/>
          </p:nvSpPr>
          <p:spPr>
            <a:xfrm>
              <a:off x="50760" y="80532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テキスト ボックス 66"/>
            <p:cNvSpPr/>
            <p:nvPr/>
          </p:nvSpPr>
          <p:spPr>
            <a:xfrm>
              <a:off x="50760" y="483840"/>
              <a:ext cx="320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05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TextBox 915"/>
            <p:cNvSpPr/>
            <p:nvPr/>
          </p:nvSpPr>
          <p:spPr>
            <a:xfrm>
              <a:off x="127800" y="79200"/>
              <a:ext cx="256680" cy="42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11" name="Picture 2" descr="D:\N-DSP 2008\SEC-A2.jpg"/>
            <p:cNvPicPr/>
            <p:nvPr/>
          </p:nvPicPr>
          <p:blipFill>
            <a:blip r:embed="rId14"/>
            <a:srcRect l="29756" t="32919" r="7613" b="8230"/>
            <a:stretch/>
          </p:blipFill>
          <p:spPr>
            <a:xfrm>
              <a:off x="444240" y="1185120"/>
              <a:ext cx="3295800" cy="154800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12" name="Picture 4" descr="D:\N-DSP 2008\SEC-32K.jpg"/>
            <p:cNvPicPr/>
            <p:nvPr/>
          </p:nvPicPr>
          <p:blipFill>
            <a:blip r:embed="rId15"/>
            <a:srcRect l="29663" t="26838" r="7928" b="9058"/>
            <a:stretch/>
          </p:blipFill>
          <p:spPr>
            <a:xfrm>
              <a:off x="444240" y="2814120"/>
              <a:ext cx="3295800" cy="153324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13" name="Picture 5" descr="D:\N-DSP 2008\SEC-N-DSP.jpg"/>
            <p:cNvPicPr/>
            <p:nvPr/>
          </p:nvPicPr>
          <p:blipFill>
            <a:blip r:embed="rId16"/>
            <a:srcRect l="29756" t="31808" r="7953" b="8264"/>
            <a:stretch/>
          </p:blipFill>
          <p:spPr>
            <a:xfrm>
              <a:off x="444240" y="4424400"/>
              <a:ext cx="3277800" cy="15688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14" name="Picture 10" descr="D:\N-DSP 2008\SEC-DPPx10.jpg"/>
            <p:cNvPicPr/>
            <p:nvPr/>
          </p:nvPicPr>
          <p:blipFill>
            <a:blip r:embed="rId17"/>
            <a:srcRect l="29756" t="29237" r="7953" b="8587"/>
            <a:stretch/>
          </p:blipFill>
          <p:spPr>
            <a:xfrm>
              <a:off x="444240" y="6077880"/>
              <a:ext cx="3277800" cy="156852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15" name="Picture 3" descr="D:\N-DSP 2008\SEC-reagent only.jpg"/>
            <p:cNvPicPr/>
            <p:nvPr/>
          </p:nvPicPr>
          <p:blipFill>
            <a:blip r:embed="rId18"/>
            <a:srcRect l="29663" t="61650" r="7928" b="9633"/>
            <a:stretch/>
          </p:blipFill>
          <p:spPr>
            <a:xfrm>
              <a:off x="444240" y="212040"/>
              <a:ext cx="3295800" cy="89604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16" name="Picture 6" descr="D:\N-DSP 2008\SEC-DGP.jpg"/>
            <p:cNvPicPr/>
            <p:nvPr/>
          </p:nvPicPr>
          <p:blipFill>
            <a:blip r:embed="rId19"/>
            <a:srcRect l="29756" t="31524" r="7953" b="8299"/>
            <a:stretch/>
          </p:blipFill>
          <p:spPr>
            <a:xfrm>
              <a:off x="3878640" y="1185120"/>
              <a:ext cx="3277800" cy="15688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17" name="Picture 7" descr="D:\N-DSP 2008\SEC-R3.jpg"/>
            <p:cNvPicPr/>
            <p:nvPr/>
          </p:nvPicPr>
          <p:blipFill>
            <a:blip r:embed="rId20"/>
            <a:srcRect l="29756" t="31874" r="7953" b="8440"/>
            <a:stretch/>
          </p:blipFill>
          <p:spPr>
            <a:xfrm>
              <a:off x="3878640" y="2828520"/>
              <a:ext cx="3277800" cy="15310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18" name="Picture 8" descr="D:\N-DSP 2008\SEC-R4.jpg"/>
            <p:cNvPicPr/>
            <p:nvPr/>
          </p:nvPicPr>
          <p:blipFill>
            <a:blip r:embed="rId21"/>
            <a:srcRect l="29756" t="31745" r="7953" b="8280"/>
            <a:stretch/>
          </p:blipFill>
          <p:spPr>
            <a:xfrm>
              <a:off x="3878640" y="4434120"/>
              <a:ext cx="3277800" cy="156852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19" name="Picture 9" descr="D:\N-DSP 2008\SEC-R5.jpg"/>
            <p:cNvPicPr/>
            <p:nvPr/>
          </p:nvPicPr>
          <p:blipFill>
            <a:blip r:embed="rId22"/>
            <a:srcRect l="29756" t="31487" r="7953" b="8299"/>
            <a:stretch/>
          </p:blipFill>
          <p:spPr>
            <a:xfrm>
              <a:off x="3878640" y="6077520"/>
              <a:ext cx="3277800" cy="156888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pic>
          <p:nvPicPr>
            <p:cNvPr id="320" name="Picture 3" descr="D:\N-DSP 2008\SEC-reagent only.jpg"/>
            <p:cNvPicPr/>
            <p:nvPr/>
          </p:nvPicPr>
          <p:blipFill>
            <a:blip r:embed="rId23"/>
            <a:srcRect l="29663" t="61650" r="7928" b="9633"/>
            <a:stretch/>
          </p:blipFill>
          <p:spPr>
            <a:xfrm>
              <a:off x="3860640" y="212040"/>
              <a:ext cx="3295800" cy="896040"/>
            </a:xfrm>
            <a:prstGeom prst="rect">
              <a:avLst/>
            </a:prstGeom>
            <a:ln w="6480">
              <a:solidFill>
                <a:srgbClr val="000000"/>
              </a:solidFill>
              <a:miter/>
            </a:ln>
          </p:spPr>
        </p:pic>
        <p:sp>
          <p:nvSpPr>
            <p:cNvPr id="321" name="テキスト ボックス 40"/>
            <p:cNvSpPr/>
            <p:nvPr/>
          </p:nvSpPr>
          <p:spPr>
            <a:xfrm>
              <a:off x="5761800" y="212040"/>
              <a:ext cx="13525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agent only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テキスト ボックス 36"/>
            <p:cNvSpPr/>
            <p:nvPr/>
          </p:nvSpPr>
          <p:spPr>
            <a:xfrm>
              <a:off x="2511720" y="4424400"/>
              <a:ext cx="11757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MW-DSP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テキスト ボックス 66"/>
            <p:cNvSpPr/>
            <p:nvPr/>
          </p:nvSpPr>
          <p:spPr>
            <a:xfrm>
              <a:off x="2927520" y="2814120"/>
              <a:ext cx="76716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-kD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テキスト ボックス 36"/>
            <p:cNvSpPr/>
            <p:nvPr/>
          </p:nvSpPr>
          <p:spPr>
            <a:xfrm>
              <a:off x="3214440" y="6077880"/>
              <a:ext cx="4687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PP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テキスト ボックス 40"/>
            <p:cNvSpPr/>
            <p:nvPr/>
          </p:nvSpPr>
          <p:spPr>
            <a:xfrm>
              <a:off x="2345760" y="212040"/>
              <a:ext cx="13525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agent only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テキスト ボックス 38"/>
            <p:cNvSpPr/>
            <p:nvPr/>
          </p:nvSpPr>
          <p:spPr>
            <a:xfrm>
              <a:off x="6265080" y="2828520"/>
              <a:ext cx="851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3-DSP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テキスト ボックス 42"/>
            <p:cNvSpPr/>
            <p:nvPr/>
          </p:nvSpPr>
          <p:spPr>
            <a:xfrm>
              <a:off x="6265080" y="4434120"/>
              <a:ext cx="851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4-DSP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テキスト ボックス 46"/>
            <p:cNvSpPr/>
            <p:nvPr/>
          </p:nvSpPr>
          <p:spPr>
            <a:xfrm>
              <a:off x="6265080" y="6077520"/>
              <a:ext cx="851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5-DSP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テキスト ボックス 48"/>
            <p:cNvSpPr/>
            <p:nvPr/>
          </p:nvSpPr>
          <p:spPr>
            <a:xfrm>
              <a:off x="6606000" y="1185120"/>
              <a:ext cx="51120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GP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テキスト ボックス 66"/>
            <p:cNvSpPr/>
            <p:nvPr/>
          </p:nvSpPr>
          <p:spPr>
            <a:xfrm>
              <a:off x="1668600" y="1185120"/>
              <a:ext cx="20275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2 glycan Standard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テキスト ボックス 66"/>
            <p:cNvSpPr/>
            <p:nvPr/>
          </p:nvSpPr>
          <p:spPr>
            <a:xfrm>
              <a:off x="1647360" y="62172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テキスト ボックス 66"/>
            <p:cNvSpPr/>
            <p:nvPr/>
          </p:nvSpPr>
          <p:spPr>
            <a:xfrm>
              <a:off x="1647360" y="208224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テキスト ボックス 66"/>
            <p:cNvSpPr/>
            <p:nvPr/>
          </p:nvSpPr>
          <p:spPr>
            <a:xfrm>
              <a:off x="1647360" y="386028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テキスト ボックス 66"/>
            <p:cNvSpPr/>
            <p:nvPr/>
          </p:nvSpPr>
          <p:spPr>
            <a:xfrm>
              <a:off x="1647360" y="544788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テキスト ボックス 66"/>
            <p:cNvSpPr/>
            <p:nvPr/>
          </p:nvSpPr>
          <p:spPr>
            <a:xfrm>
              <a:off x="1647360" y="708444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テキスト ボックス 66"/>
            <p:cNvSpPr/>
            <p:nvPr/>
          </p:nvSpPr>
          <p:spPr>
            <a:xfrm>
              <a:off x="5127480" y="68220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テキスト ボックス 66"/>
            <p:cNvSpPr/>
            <p:nvPr/>
          </p:nvSpPr>
          <p:spPr>
            <a:xfrm>
              <a:off x="5127480" y="124092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テキスト ボックス 66"/>
            <p:cNvSpPr/>
            <p:nvPr/>
          </p:nvSpPr>
          <p:spPr>
            <a:xfrm>
              <a:off x="5114520" y="365400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テキスト ボックス 66"/>
            <p:cNvSpPr/>
            <p:nvPr/>
          </p:nvSpPr>
          <p:spPr>
            <a:xfrm>
              <a:off x="5089320" y="554652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テキスト ボックス 66"/>
            <p:cNvSpPr/>
            <p:nvPr/>
          </p:nvSpPr>
          <p:spPr>
            <a:xfrm>
              <a:off x="5114520" y="7045200"/>
              <a:ext cx="1364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619200"/>
                  <a:tab algn="l" pos="1238400"/>
                  <a:tab algn="l" pos="1857240"/>
                  <a:tab algn="l" pos="2476440"/>
                  <a:tab algn="l" pos="3095640"/>
                  <a:tab algn="l" pos="3714840"/>
                  <a:tab algn="l" pos="4334040"/>
                  <a:tab algn="l" pos="4952880"/>
                  <a:tab algn="l" pos="5572080"/>
                  <a:tab algn="l" pos="6191280"/>
                  <a:tab algn="l" pos="6810480"/>
                  <a:tab algn="l" pos="7429680"/>
                  <a:tab algn="l" pos="8048520"/>
                  <a:tab algn="l" pos="8667720"/>
                  <a:tab algn="l" pos="9286920"/>
                  <a:tab algn="l" pos="9906120"/>
                  <a:tab algn="l" pos="1052496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直線コネクタ 276"/>
            <p:cNvSpPr/>
            <p:nvPr/>
          </p:nvSpPr>
          <p:spPr>
            <a:xfrm flipV="1">
              <a:off x="1206360" y="2474640"/>
              <a:ext cx="342720" cy="102960"/>
            </a:xfrm>
            <a:prstGeom prst="line">
              <a:avLst/>
            </a:prstGeom>
            <a:ln w="1260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直線コネクタ 278"/>
            <p:cNvSpPr/>
            <p:nvPr/>
          </p:nvSpPr>
          <p:spPr>
            <a:xfrm flipV="1">
              <a:off x="1137960" y="4208400"/>
              <a:ext cx="466560" cy="1440"/>
            </a:xfrm>
            <a:prstGeom prst="line">
              <a:avLst/>
            </a:prstGeom>
            <a:ln w="1260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直線コネクタ 279"/>
            <p:cNvSpPr/>
            <p:nvPr/>
          </p:nvSpPr>
          <p:spPr>
            <a:xfrm flipV="1">
              <a:off x="1120680" y="5827680"/>
              <a:ext cx="502920" cy="1440"/>
            </a:xfrm>
            <a:prstGeom prst="line">
              <a:avLst/>
            </a:prstGeom>
            <a:ln w="1260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直線コネクタ 283"/>
            <p:cNvSpPr/>
            <p:nvPr/>
          </p:nvSpPr>
          <p:spPr>
            <a:xfrm>
              <a:off x="1288800" y="7429680"/>
              <a:ext cx="280800" cy="0"/>
            </a:xfrm>
            <a:prstGeom prst="line">
              <a:avLst/>
            </a:prstGeom>
            <a:ln w="1260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直線コネクタ 285"/>
            <p:cNvSpPr/>
            <p:nvPr/>
          </p:nvSpPr>
          <p:spPr>
            <a:xfrm>
              <a:off x="4576680" y="7434360"/>
              <a:ext cx="504720" cy="0"/>
            </a:xfrm>
            <a:prstGeom prst="line">
              <a:avLst/>
            </a:prstGeom>
            <a:ln w="1260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直線コネクタ 287"/>
            <p:cNvSpPr/>
            <p:nvPr/>
          </p:nvSpPr>
          <p:spPr>
            <a:xfrm>
              <a:off x="4572000" y="5819760"/>
              <a:ext cx="468000" cy="0"/>
            </a:xfrm>
            <a:prstGeom prst="line">
              <a:avLst/>
            </a:prstGeom>
            <a:ln w="1260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直線コネクタ 289"/>
            <p:cNvSpPr/>
            <p:nvPr/>
          </p:nvSpPr>
          <p:spPr>
            <a:xfrm flipV="1">
              <a:off x="4484880" y="2545920"/>
              <a:ext cx="596880" cy="34920"/>
            </a:xfrm>
            <a:prstGeom prst="line">
              <a:avLst/>
            </a:prstGeom>
            <a:ln w="1260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8" name="Rectangle 975"/>
          <p:cNvSpPr/>
          <p:nvPr/>
        </p:nvSpPr>
        <p:spPr>
          <a:xfrm>
            <a:off x="598320" y="9772560"/>
            <a:ext cx="16542000" cy="825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619200"/>
                <a:tab algn="l" pos="1238400"/>
                <a:tab algn="l" pos="1857240"/>
                <a:tab algn="l" pos="2476440"/>
                <a:tab algn="l" pos="3095640"/>
                <a:tab algn="l" pos="3714840"/>
                <a:tab algn="l" pos="4334040"/>
                <a:tab algn="l" pos="4952880"/>
                <a:tab algn="l" pos="5572080"/>
                <a:tab algn="l" pos="6191280"/>
                <a:tab algn="l" pos="6810480"/>
                <a:tab algn="l" pos="7429680"/>
                <a:tab algn="l" pos="8048520"/>
                <a:tab algn="l" pos="8667720"/>
                <a:tab algn="l" pos="9286920"/>
                <a:tab algn="l" pos="9906120"/>
                <a:tab algn="l" pos="1052496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5. Characterization of sialic acid in Dsp N-glycosylations. </a:t>
            </a:r>
            <a:r>
              <a:rPr b="1" i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:</a:t>
            </a: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luorescent chromatograms (Abs</a:t>
            </a:r>
            <a:r>
              <a:rPr b="0" lang="en-US" sz="2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20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. min; excitation wavelength 320 nm) from size exclusion-HPLC (SE-HPLC) separations of N-glycosylations released from various Dsp fractions by glycopeptidase A digestion and then labeled with 2-AA. The amount of released N-glycosylation was determined by calculating the areas under the glycosylation peaks relative to a 10 pmol A2 glycan standard. Peaks labeled “R” are reagent peaks and are not made by labeled N-glycosylations. Red dotted lines show the baselines used to determine the areas under the curves. </a:t>
            </a:r>
            <a:r>
              <a:rPr b="1" i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: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luorescent chromatograms (Abs</a:t>
            </a:r>
            <a:r>
              <a:rPr b="0" lang="en-US" sz="2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48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. min; excitation wavelength 373 nm) from RP-HPLC separations of sialic acid released from the 2-AA labeled N-glycosylations by sialidase disgestion and labeled with DMB. The type of sialic acid in the samples was identified by comparing their peak retention times with those of a DMB labeled sialic acid reference panel. </a:t>
            </a:r>
            <a:r>
              <a:rPr b="1" i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: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etention times of samples varied slightly according to the freshness of the buffer (top), so we confirmed sialic acid characterization by combining experimental samples, such as the 32-kDa enamelin (middle), with the standards samples. </a:t>
            </a:r>
            <a:r>
              <a:rPr b="1" i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ey to standards: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: N-glycolylneuraminic acid (Neu5Gc); b: N-acetylneuraminic acid (Neu5Ac); c: Neu5Gc9Ac; d: Neu5,9Ac</a:t>
            </a:r>
            <a:r>
              <a:rPr b="0" lang="en-US" sz="2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; e: reagent; f: Neu5,7(8),9Ac</a:t>
            </a:r>
            <a:r>
              <a:rPr b="0" lang="en-US" sz="2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only form of sialic acid detected in Dsp was N-acetylneuraminic acid (Neu5Ac), which is the same form of sialic acid that is found in the 32-kDa enamelin. </a:t>
            </a:r>
            <a:r>
              <a:rPr b="1" i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: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able showing the quantitative determination of the average number of sialic acid moieties per N-linked glycosylation on the HMW Dsp in fraction ANS1/2-R5 and the LMW Dsp in fraction AS2R-g. The quantity of sialic acid was determined by digesting a weighed sample of Dsp a bovine fetuin standard with sialidase, reacting the products with lactate dehydrogenase and ß-NADH, and reading the Abs</a:t>
            </a:r>
            <a:r>
              <a:rPr b="0" lang="en-US" sz="28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40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n a spectrophotometer.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0T15:55:47Z</dcterms:created>
  <dc:creator>James Simmer</dc:creator>
  <dc:description/>
  <dc:language>en-US</dc:language>
  <cp:lastModifiedBy>James Simmer</cp:lastModifiedBy>
  <cp:lastPrinted>2010-03-15T16:11:36Z</cp:lastPrinted>
  <dcterms:modified xsi:type="dcterms:W3CDTF">2011-01-20T16:54:26Z</dcterms:modified>
  <cp:revision>19</cp:revision>
  <dc:subject/>
  <dc:title>Slide 1</dc:title>
</cp:coreProperties>
</file>